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</p:sldIdLst>
  <p:sldSz cx="77724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5"/>
    <p:restoredTop sz="96197"/>
  </p:normalViewPr>
  <p:slideViewPr>
    <p:cSldViewPr snapToGrid="0" snapToObjects="1">
      <p:cViewPr varScale="1">
        <p:scale>
          <a:sx n="93" d="100"/>
          <a:sy n="93" d="100"/>
        </p:scale>
        <p:origin x="245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496484"/>
            <a:ext cx="6606540" cy="3183467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4802717"/>
            <a:ext cx="5829300" cy="2207683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8F26E-FE55-FF4D-B78A-CD6B60FB486B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4AF6D-B10B-6D47-A420-7D2ED12ADB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123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8F26E-FE55-FF4D-B78A-CD6B60FB486B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4AF6D-B10B-6D47-A420-7D2ED12ADB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88194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486834"/>
            <a:ext cx="1675924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486834"/>
            <a:ext cx="4930616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8F26E-FE55-FF4D-B78A-CD6B60FB486B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4AF6D-B10B-6D47-A420-7D2ED12ADB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14040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8F26E-FE55-FF4D-B78A-CD6B60FB486B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4AF6D-B10B-6D47-A420-7D2ED12ADB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2463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279653"/>
            <a:ext cx="6703695" cy="3803649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119286"/>
            <a:ext cx="6703695" cy="2000249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8F26E-FE55-FF4D-B78A-CD6B60FB486B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4AF6D-B10B-6D47-A420-7D2ED12ADB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3156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434167"/>
            <a:ext cx="330327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434167"/>
            <a:ext cx="330327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8F26E-FE55-FF4D-B78A-CD6B60FB486B}" type="datetimeFigureOut">
              <a:rPr lang="en-US" smtClean="0"/>
              <a:t>2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4AF6D-B10B-6D47-A420-7D2ED12ADB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44483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486836"/>
            <a:ext cx="670369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241551"/>
            <a:ext cx="3288089" cy="1098549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340100"/>
            <a:ext cx="3288089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241551"/>
            <a:ext cx="3304282" cy="1098549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340100"/>
            <a:ext cx="3304282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8F26E-FE55-FF4D-B78A-CD6B60FB486B}" type="datetimeFigureOut">
              <a:rPr lang="en-US" smtClean="0"/>
              <a:t>2/21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4AF6D-B10B-6D47-A420-7D2ED12ADB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0576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8F26E-FE55-FF4D-B78A-CD6B60FB486B}" type="datetimeFigureOut">
              <a:rPr lang="en-US" smtClean="0"/>
              <a:t>2/21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4AF6D-B10B-6D47-A420-7D2ED12ADB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9786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8F26E-FE55-FF4D-B78A-CD6B60FB486B}" type="datetimeFigureOut">
              <a:rPr lang="en-US" smtClean="0"/>
              <a:t>2/21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4AF6D-B10B-6D47-A420-7D2ED12ADB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8058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09600"/>
            <a:ext cx="2506801" cy="213360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316569"/>
            <a:ext cx="3934778" cy="6498167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2743200"/>
            <a:ext cx="2506801" cy="5082117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8F26E-FE55-FF4D-B78A-CD6B60FB486B}" type="datetimeFigureOut">
              <a:rPr lang="en-US" smtClean="0"/>
              <a:t>2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4AF6D-B10B-6D47-A420-7D2ED12ADB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527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09600"/>
            <a:ext cx="2506801" cy="213360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316569"/>
            <a:ext cx="3934778" cy="6498167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2743200"/>
            <a:ext cx="2506801" cy="5082117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8F26E-FE55-FF4D-B78A-CD6B60FB486B}" type="datetimeFigureOut">
              <a:rPr lang="en-US" smtClean="0"/>
              <a:t>2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4AF6D-B10B-6D47-A420-7D2ED12ADB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621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486836"/>
            <a:ext cx="670369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434167"/>
            <a:ext cx="670369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8475136"/>
            <a:ext cx="174879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E8F26E-FE55-FF4D-B78A-CD6B60FB486B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8475136"/>
            <a:ext cx="262318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8475136"/>
            <a:ext cx="174879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A4AF6D-B10B-6D47-A420-7D2ED12ADB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69402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86EE2F1-800A-3F41-93FC-19C12C4233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3291" y="0"/>
            <a:ext cx="7065818" cy="914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25836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3DE56288-DBEA-D740-B76B-1E870CF20E8A}"/>
              </a:ext>
            </a:extLst>
          </p:cNvPr>
          <p:cNvSpPr/>
          <p:nvPr/>
        </p:nvSpPr>
        <p:spPr>
          <a:xfrm>
            <a:off x="401782" y="370850"/>
            <a:ext cx="7218218" cy="16158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Calibri" panose="020F0502020204030204" pitchFamily="34" charset="0"/>
              </a:rPr>
              <a:t>Supplementary Figure 5. Periventricular T2 signal (blue) around the lateral ventricles is associated with ventricle volume. </a:t>
            </a:r>
            <a:r>
              <a:rPr lang="en-US" sz="1100" dirty="0">
                <a:latin typeface="Calibri" panose="020F0502020204030204" pitchFamily="34" charset="0"/>
              </a:rPr>
              <a:t>(A) Representative T2-weighted MRIs of 3 brain regions in RCAS-based GEMMs of DIPG showing location of periventricular T2 signal around the anterior horns of the lateral ventricles 3 weeks post-injection. Scalebars = 5 mm. (B) Representative T2-weighted MRIs of 3 brain regions in RCAS-based GEMMs of DIPG showing location of diffuse periventricular T2 signal in areas adjacent to the lateral ventricles. Scalebars = 5 mm. (C) Periventricular T2 signal (blue outline) corresponds with regions of lighter staining observed on H&amp;E images. Black arrows on the H&amp;E images indicate the periventricular areas with lighter staining. C 2.5x magnification, scalebars = 5 mm. (D) Photomicrograph showing pale, edematous appearance of periventricular regions on H&amp;E images. Black asterisks indicate areas of hemorrhage. D scalebar = 5 mm. (E) Quantification of ventricle and periventricular T2 signal volume (n = 33; r = 0.87; p &lt; 0.0001; Linear regression analysis). </a:t>
            </a:r>
            <a:endParaRPr lang="en-US" sz="1100" dirty="0"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8967296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200</Words>
  <Application>Microsoft Macintosh PowerPoint</Application>
  <PresentationFormat>Custom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, Shelei</dc:creator>
  <cp:lastModifiedBy>Pan, Shelei</cp:lastModifiedBy>
  <cp:revision>1</cp:revision>
  <dcterms:created xsi:type="dcterms:W3CDTF">2022-02-21T16:52:55Z</dcterms:created>
  <dcterms:modified xsi:type="dcterms:W3CDTF">2022-02-21T16:54:04Z</dcterms:modified>
</cp:coreProperties>
</file>